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12192000" cy="1440021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4" autoAdjust="0"/>
    <p:restoredTop sz="95494" autoAdjust="0"/>
  </p:normalViewPr>
  <p:slideViewPr>
    <p:cSldViewPr snapToGrid="0">
      <p:cViewPr varScale="1">
        <p:scale>
          <a:sx n="41" d="100"/>
          <a:sy n="41" d="100"/>
        </p:scale>
        <p:origin x="23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DC292E-CA66-4DEE-A07A-76CF31F0C8E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143000"/>
            <a:ext cx="2613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ED13A2-6E1D-4F71-98DF-2677D193665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6250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6703"/>
            <a:ext cx="10363200" cy="50134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63446"/>
            <a:ext cx="9144000" cy="347671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8716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3187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6678"/>
            <a:ext cx="2628900" cy="1220351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6678"/>
            <a:ext cx="7734300" cy="1220351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7483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1384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0057"/>
            <a:ext cx="10515600" cy="599008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36813"/>
            <a:ext cx="10515600" cy="315004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9454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3390"/>
            <a:ext cx="5181600" cy="913680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3390"/>
            <a:ext cx="5181600" cy="913680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54065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6681"/>
            <a:ext cx="10515600" cy="278337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0053"/>
            <a:ext cx="5157787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0078"/>
            <a:ext cx="5157787" cy="773678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0053"/>
            <a:ext cx="5183188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0078"/>
            <a:ext cx="5183188" cy="773678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9526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243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2996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3367"/>
            <a:ext cx="6172200" cy="10233485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872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3367"/>
            <a:ext cx="6172200" cy="10233485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8530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6681"/>
            <a:ext cx="105156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3390"/>
            <a:ext cx="105156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E1621-11DA-47B7-BA1F-0A0FDE5F32CF}" type="datetimeFigureOut">
              <a:rPr lang="ko-KR" altLang="en-US" smtClean="0"/>
              <a:t>2020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8166F-AD34-435B-A850-8D42020048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5495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1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1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png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그림 3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65" t="43139" r="36142" b="41546"/>
          <a:stretch/>
        </p:blipFill>
        <p:spPr>
          <a:xfrm>
            <a:off x="7552490" y="9982656"/>
            <a:ext cx="3473409" cy="626352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3"/>
          <a:srcRect l="28085" t="42364" r="24612" b="43973"/>
          <a:stretch/>
        </p:blipFill>
        <p:spPr>
          <a:xfrm>
            <a:off x="2098356" y="6619088"/>
            <a:ext cx="2868067" cy="53175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057989" y="6664432"/>
            <a:ext cx="638316" cy="509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n-US" altLang="ko-KR" sz="1355" dirty="0" err="1"/>
              <a:t>Bax</a:t>
            </a:r>
            <a:endParaRPr lang="ko-KR" altLang="en-US" sz="1355" dirty="0"/>
          </a:p>
        </p:txBody>
      </p:sp>
      <p:sp>
        <p:nvSpPr>
          <p:cNvPr id="7" name="TextBox 6"/>
          <p:cNvSpPr txBox="1"/>
          <p:nvPr/>
        </p:nvSpPr>
        <p:spPr>
          <a:xfrm>
            <a:off x="1722507" y="6641760"/>
            <a:ext cx="824456" cy="509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n-US" altLang="ko-KR" sz="1355" dirty="0"/>
              <a:t>caspase3</a:t>
            </a:r>
            <a:endParaRPr lang="ko-KR" altLang="en-US" sz="1355" dirty="0"/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4"/>
          <a:srcRect l="17160" t="2498" r="14997" b="-449"/>
          <a:stretch/>
        </p:blipFill>
        <p:spPr>
          <a:xfrm>
            <a:off x="8773473" y="8257208"/>
            <a:ext cx="1199189" cy="1213092"/>
          </a:xfrm>
          <a:prstGeom prst="rect">
            <a:avLst/>
          </a:prstGeom>
        </p:spPr>
      </p:pic>
      <p:sp>
        <p:nvSpPr>
          <p:cNvPr id="9" name="직사각형 8"/>
          <p:cNvSpPr/>
          <p:nvPr/>
        </p:nvSpPr>
        <p:spPr>
          <a:xfrm>
            <a:off x="8866865" y="8590046"/>
            <a:ext cx="1012402" cy="31515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11" name="TextBox 10"/>
          <p:cNvSpPr txBox="1"/>
          <p:nvPr/>
        </p:nvSpPr>
        <p:spPr>
          <a:xfrm>
            <a:off x="9879267" y="8458135"/>
            <a:ext cx="824456" cy="509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/>
              <a:t>HDF</a:t>
            </a:r>
          </a:p>
          <a:p>
            <a:r>
              <a:rPr lang="en-US" altLang="ko-KR" sz="1355" dirty="0"/>
              <a:t>caspase3</a:t>
            </a:r>
            <a:endParaRPr lang="ko-KR" altLang="en-US" sz="1355" dirty="0"/>
          </a:p>
        </p:txBody>
      </p:sp>
      <p:sp>
        <p:nvSpPr>
          <p:cNvPr id="12" name="직사각형 11"/>
          <p:cNvSpPr/>
          <p:nvPr/>
        </p:nvSpPr>
        <p:spPr>
          <a:xfrm>
            <a:off x="2433190" y="6813017"/>
            <a:ext cx="1012402" cy="31515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13" name="직사각형 12"/>
          <p:cNvSpPr/>
          <p:nvPr/>
        </p:nvSpPr>
        <p:spPr>
          <a:xfrm>
            <a:off x="3493602" y="6750060"/>
            <a:ext cx="1012402" cy="31515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10" name="TextBox 9"/>
          <p:cNvSpPr txBox="1"/>
          <p:nvPr/>
        </p:nvSpPr>
        <p:spPr>
          <a:xfrm>
            <a:off x="950169" y="2812232"/>
            <a:ext cx="17499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/>
              <a:t>Figure 3. B</a:t>
            </a:r>
            <a:endParaRPr lang="ko-KR" altLang="en-US" sz="2800" b="1" dirty="0"/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59315" y="4492930"/>
            <a:ext cx="1668399" cy="795041"/>
          </a:xfrm>
          <a:prstGeom prst="rect">
            <a:avLst/>
          </a:prstGeom>
        </p:spPr>
      </p:pic>
      <p:sp>
        <p:nvSpPr>
          <p:cNvPr id="15" name="직사각형 14"/>
          <p:cNvSpPr/>
          <p:nvPr/>
        </p:nvSpPr>
        <p:spPr>
          <a:xfrm>
            <a:off x="8960259" y="4734764"/>
            <a:ext cx="1012402" cy="31515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16" name="TextBox 15"/>
          <p:cNvSpPr txBox="1"/>
          <p:nvPr/>
        </p:nvSpPr>
        <p:spPr>
          <a:xfrm>
            <a:off x="10121071" y="4647246"/>
            <a:ext cx="534121" cy="509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/>
              <a:t>HDF</a:t>
            </a:r>
          </a:p>
          <a:p>
            <a:r>
              <a:rPr lang="en-US" altLang="ko-KR" sz="1355" dirty="0"/>
              <a:t>Bcl-2</a:t>
            </a:r>
            <a:endParaRPr lang="ko-KR" altLang="en-US" sz="1355" dirty="0"/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33" t="39972" r="35065" b="39954"/>
          <a:stretch/>
        </p:blipFill>
        <p:spPr>
          <a:xfrm>
            <a:off x="1870913" y="3974990"/>
            <a:ext cx="3103853" cy="781339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4809772" y="4095800"/>
            <a:ext cx="1679928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n-US" altLang="ko-KR" sz="1355" dirty="0"/>
              <a:t>bcl-2</a:t>
            </a:r>
            <a:endParaRPr lang="ko-KR" altLang="en-US" sz="1355" dirty="0"/>
          </a:p>
        </p:txBody>
      </p:sp>
      <p:pic>
        <p:nvPicPr>
          <p:cNvPr id="19" name="그림 1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36" t="43044" r="37607" b="40934"/>
          <a:stretch/>
        </p:blipFill>
        <p:spPr>
          <a:xfrm>
            <a:off x="2078792" y="5093239"/>
            <a:ext cx="2831459" cy="623637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4896037" y="5026267"/>
            <a:ext cx="1679928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n-US" altLang="ko-KR" sz="1355" dirty="0" err="1"/>
              <a:t>parp</a:t>
            </a:r>
            <a:endParaRPr lang="ko-KR" altLang="en-US" sz="1355" dirty="0"/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92" t="44538" r="36422" b="40513"/>
          <a:stretch/>
        </p:blipFill>
        <p:spPr>
          <a:xfrm>
            <a:off x="2071500" y="5647602"/>
            <a:ext cx="2738272" cy="896031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4117585" y="5801822"/>
            <a:ext cx="1679928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 err="1"/>
              <a:t>HaCaT</a:t>
            </a:r>
            <a:endParaRPr lang="en-US" altLang="ko-KR" sz="1355" dirty="0"/>
          </a:p>
          <a:p>
            <a:r>
              <a:rPr lang="en-US" altLang="ko-KR" sz="1355" dirty="0"/>
              <a:t>actin</a:t>
            </a:r>
            <a:endParaRPr lang="ko-KR" altLang="en-US" sz="1355" dirty="0"/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84" t="38222" r="36067" b="37925"/>
          <a:stretch/>
        </p:blipFill>
        <p:spPr>
          <a:xfrm>
            <a:off x="7527977" y="3631570"/>
            <a:ext cx="3025684" cy="928459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10441318" y="3844526"/>
            <a:ext cx="481222" cy="509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/>
              <a:t>HDF</a:t>
            </a:r>
          </a:p>
          <a:p>
            <a:r>
              <a:rPr lang="en-US" altLang="ko-KR" sz="1355" dirty="0" err="1"/>
              <a:t>Bax</a:t>
            </a:r>
            <a:endParaRPr lang="ko-KR" altLang="en-US" sz="1355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483232" y="5223337"/>
            <a:ext cx="3885623" cy="2722443"/>
          </a:xfrm>
          <a:prstGeom prst="rect">
            <a:avLst/>
          </a:prstGeom>
        </p:spPr>
      </p:pic>
      <p:sp>
        <p:nvSpPr>
          <p:cNvPr id="25" name="직사각형 24"/>
          <p:cNvSpPr/>
          <p:nvPr/>
        </p:nvSpPr>
        <p:spPr>
          <a:xfrm>
            <a:off x="9104758" y="6537402"/>
            <a:ext cx="1012402" cy="31515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26" name="TextBox 25"/>
          <p:cNvSpPr txBox="1"/>
          <p:nvPr/>
        </p:nvSpPr>
        <p:spPr>
          <a:xfrm>
            <a:off x="10117160" y="6405491"/>
            <a:ext cx="546945" cy="5093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5" dirty="0"/>
              <a:t>HDF</a:t>
            </a:r>
          </a:p>
          <a:p>
            <a:r>
              <a:rPr lang="en-US" altLang="ko-KR" sz="1355" dirty="0"/>
              <a:t>PARP</a:t>
            </a:r>
            <a:endParaRPr lang="ko-KR" altLang="en-US" sz="1355" dirty="0"/>
          </a:p>
        </p:txBody>
      </p:sp>
      <p:sp>
        <p:nvSpPr>
          <p:cNvPr id="28" name="TextBox 27"/>
          <p:cNvSpPr txBox="1"/>
          <p:nvPr/>
        </p:nvSpPr>
        <p:spPr>
          <a:xfrm>
            <a:off x="10448341" y="10015452"/>
            <a:ext cx="1679928" cy="5093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55" dirty="0"/>
              <a:t>HDF</a:t>
            </a:r>
          </a:p>
          <a:p>
            <a:r>
              <a:rPr lang="en-US" altLang="ko-KR" sz="1355" dirty="0"/>
              <a:t>actin</a:t>
            </a:r>
            <a:endParaRPr lang="ko-KR" altLang="en-US" sz="1355" dirty="0"/>
          </a:p>
        </p:txBody>
      </p:sp>
      <p:sp>
        <p:nvSpPr>
          <p:cNvPr id="31" name="직사각형 30"/>
          <p:cNvSpPr/>
          <p:nvPr/>
        </p:nvSpPr>
        <p:spPr>
          <a:xfrm>
            <a:off x="8055878" y="10101080"/>
            <a:ext cx="2061282" cy="400782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33" name="직사각형 32"/>
          <p:cNvSpPr/>
          <p:nvPr/>
        </p:nvSpPr>
        <p:spPr>
          <a:xfrm>
            <a:off x="2624809" y="5787318"/>
            <a:ext cx="1439589" cy="36935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34" name="직사각형 33"/>
          <p:cNvSpPr/>
          <p:nvPr/>
        </p:nvSpPr>
        <p:spPr>
          <a:xfrm>
            <a:off x="2624808" y="4159476"/>
            <a:ext cx="1812339" cy="40123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35" name="직사각형 34"/>
          <p:cNvSpPr/>
          <p:nvPr/>
        </p:nvSpPr>
        <p:spPr>
          <a:xfrm>
            <a:off x="2624808" y="5162862"/>
            <a:ext cx="1812339" cy="40123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  <p:sp>
        <p:nvSpPr>
          <p:cNvPr id="36" name="직사각형 35"/>
          <p:cNvSpPr/>
          <p:nvPr/>
        </p:nvSpPr>
        <p:spPr>
          <a:xfrm>
            <a:off x="8240465" y="3917558"/>
            <a:ext cx="1876695" cy="400637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5"/>
          </a:p>
        </p:txBody>
      </p:sp>
    </p:spTree>
    <p:extLst>
      <p:ext uri="{BB962C8B-B14F-4D97-AF65-F5344CB8AC3E}">
        <p14:creationId xmlns:p14="http://schemas.microsoft.com/office/powerpoint/2010/main" val="1776101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3</TotalTime>
  <Words>24</Words>
  <Application>Microsoft Office PowerPoint</Application>
  <PresentationFormat>사용자 지정</PresentationFormat>
  <Paragraphs>2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3</cp:revision>
  <dcterms:created xsi:type="dcterms:W3CDTF">2020-06-04T05:19:59Z</dcterms:created>
  <dcterms:modified xsi:type="dcterms:W3CDTF">2020-08-12T05:06:50Z</dcterms:modified>
</cp:coreProperties>
</file>